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61" r:id="rId3"/>
    <p:sldId id="260" r:id="rId4"/>
    <p:sldId id="262" r:id="rId5"/>
    <p:sldId id="259" r:id="rId6"/>
    <p:sldId id="263" r:id="rId7"/>
  </p:sldIdLst>
  <p:sldSz cx="6858000" cy="12192000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84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9118" autoAdjust="0"/>
    <p:restoredTop sz="94660"/>
  </p:normalViewPr>
  <p:slideViewPr>
    <p:cSldViewPr snapToGrid="0">
      <p:cViewPr varScale="1">
        <p:scale>
          <a:sx n="66" d="100"/>
          <a:sy n="66" d="100"/>
        </p:scale>
        <p:origin x="-4146" y="-102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423CD-1DE7-40A9-A8E6-01930D4A0376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086BD-1EDA-47C3-B896-93360DD1B1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81823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423CD-1DE7-40A9-A8E6-01930D4A0376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086BD-1EDA-47C3-B896-93360DD1B1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255618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423CD-1DE7-40A9-A8E6-01930D4A0376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086BD-1EDA-47C3-B896-93360DD1B1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007720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423CD-1DE7-40A9-A8E6-01930D4A0376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086BD-1EDA-47C3-B896-93360DD1B1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511392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423CD-1DE7-40A9-A8E6-01930D4A0376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086BD-1EDA-47C3-B896-93360DD1B1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019800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423CD-1DE7-40A9-A8E6-01930D4A0376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086BD-1EDA-47C3-B896-93360DD1B1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28041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423CD-1DE7-40A9-A8E6-01930D4A0376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086BD-1EDA-47C3-B896-93360DD1B1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5232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423CD-1DE7-40A9-A8E6-01930D4A0376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086BD-1EDA-47C3-B896-93360DD1B1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33097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423CD-1DE7-40A9-A8E6-01930D4A0376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086BD-1EDA-47C3-B896-93360DD1B1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61459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423CD-1DE7-40A9-A8E6-01930D4A0376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086BD-1EDA-47C3-B896-93360DD1B1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710073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423CD-1DE7-40A9-A8E6-01930D4A0376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086BD-1EDA-47C3-B896-93360DD1B1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17763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4423CD-1DE7-40A9-A8E6-01930D4A0376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0086BD-1EDA-47C3-B896-93360DD1B1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97668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3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-36827" y="438150"/>
            <a:ext cx="29514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 Fig – Leave-one-out sensitivity analysis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" name="Group 3"/>
          <p:cNvGrpSpPr/>
          <p:nvPr/>
        </p:nvGrpSpPr>
        <p:grpSpPr>
          <a:xfrm>
            <a:off x="22211" y="3586363"/>
            <a:ext cx="6835789" cy="2667774"/>
            <a:chOff x="-36827" y="1543050"/>
            <a:chExt cx="6835789" cy="2667774"/>
          </a:xfrm>
        </p:grpSpPr>
        <p:sp>
          <p:nvSpPr>
            <p:cNvPr id="7" name="TextBox 6"/>
            <p:cNvSpPr txBox="1"/>
            <p:nvPr/>
          </p:nvSpPr>
          <p:spPr>
            <a:xfrm>
              <a:off x="-36827" y="1543050"/>
              <a:ext cx="120417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B</a:t>
              </a:r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irth weight</a:t>
              </a:r>
              <a:endParaRPr lang="en-GB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2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6687" y="1924824"/>
              <a:ext cx="6772275" cy="2286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sp>
        <p:nvSpPr>
          <p:cNvPr id="3" name="TextBox 2"/>
          <p:cNvSpPr txBox="1"/>
          <p:nvPr/>
        </p:nvSpPr>
        <p:spPr>
          <a:xfrm>
            <a:off x="-36827" y="1068245"/>
            <a:ext cx="14734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i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yburide </a:t>
            </a:r>
            <a:r>
              <a:rPr lang="en-GB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s. insulin</a:t>
            </a:r>
            <a:endParaRPr lang="en-GB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3" name="Group 12"/>
          <p:cNvGrpSpPr/>
          <p:nvPr/>
        </p:nvGrpSpPr>
        <p:grpSpPr>
          <a:xfrm>
            <a:off x="-4476" y="6254137"/>
            <a:ext cx="6862476" cy="5086736"/>
            <a:chOff x="-36827" y="4483394"/>
            <a:chExt cx="6862476" cy="5086736"/>
          </a:xfrm>
        </p:grpSpPr>
        <p:sp>
          <p:nvSpPr>
            <p:cNvPr id="9" name="TextBox 8"/>
            <p:cNvSpPr txBox="1"/>
            <p:nvPr/>
          </p:nvSpPr>
          <p:spPr>
            <a:xfrm>
              <a:off x="-36827" y="4483394"/>
              <a:ext cx="119936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C</a:t>
              </a:r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acrosomia</a:t>
              </a:r>
              <a:endParaRPr lang="en-GB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-36827" y="7285238"/>
              <a:ext cx="75212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D</a:t>
              </a:r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GA</a:t>
              </a:r>
              <a:endParaRPr lang="en-GB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0" y="4894463"/>
              <a:ext cx="6772275" cy="2286000"/>
            </a:xfrm>
            <a:prstGeom prst="rect">
              <a:avLst/>
            </a:prstGeom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3374" y="7741330"/>
              <a:ext cx="6772275" cy="1828800"/>
            </a:xfrm>
            <a:prstGeom prst="rect">
              <a:avLst/>
            </a:prstGeom>
          </p:spPr>
        </p:pic>
      </p:grpSp>
      <p:grpSp>
        <p:nvGrpSpPr>
          <p:cNvPr id="8" name="Group 7"/>
          <p:cNvGrpSpPr/>
          <p:nvPr/>
        </p:nvGrpSpPr>
        <p:grpSpPr>
          <a:xfrm>
            <a:off x="0" y="1617422"/>
            <a:ext cx="6835788" cy="1861471"/>
            <a:chOff x="-36827" y="9697277"/>
            <a:chExt cx="6835788" cy="1861471"/>
          </a:xfrm>
        </p:grpSpPr>
        <p:sp>
          <p:nvSpPr>
            <p:cNvPr id="6" name="TextBox 5"/>
            <p:cNvSpPr txBox="1"/>
            <p:nvPr/>
          </p:nvSpPr>
          <p:spPr>
            <a:xfrm>
              <a:off x="-36827" y="9697277"/>
              <a:ext cx="190308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A</a:t>
              </a:r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estational weight gain</a:t>
              </a:r>
              <a:endParaRPr lang="en-GB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6686" y="10101423"/>
              <a:ext cx="6772275" cy="1457325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6627267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5725" y="1838325"/>
            <a:ext cx="6772275" cy="1504950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85725" y="1466334"/>
            <a:ext cx="69281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E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FBS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85725" y="3797300"/>
            <a:ext cx="7008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RBS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5725" y="4528324"/>
            <a:ext cx="6772275" cy="16764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85725" y="6520249"/>
            <a:ext cx="8803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G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HbA1c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85725" y="7112774"/>
            <a:ext cx="41487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ly one study, therefore LOO analysis unable to be conducted.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3961534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762000"/>
            <a:ext cx="15247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tformin vs. insulin</a:t>
            </a:r>
            <a:endParaRPr lang="en-GB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0" name="Group 9"/>
          <p:cNvGrpSpPr/>
          <p:nvPr/>
        </p:nvGrpSpPr>
        <p:grpSpPr>
          <a:xfrm>
            <a:off x="0" y="6415125"/>
            <a:ext cx="6815138" cy="2998661"/>
            <a:chOff x="22257" y="4162770"/>
            <a:chExt cx="6815138" cy="2998661"/>
          </a:xfrm>
        </p:grpSpPr>
        <p:sp>
          <p:nvSpPr>
            <p:cNvPr id="7" name="TextBox 6"/>
            <p:cNvSpPr txBox="1"/>
            <p:nvPr/>
          </p:nvSpPr>
          <p:spPr>
            <a:xfrm>
              <a:off x="22257" y="4162770"/>
              <a:ext cx="119936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C</a:t>
              </a:r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acrosomia</a:t>
              </a:r>
              <a:endParaRPr lang="en-GB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5120" y="4570631"/>
              <a:ext cx="6772275" cy="25908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grpSp>
        <p:nvGrpSpPr>
          <p:cNvPr id="9" name="Group 8"/>
          <p:cNvGrpSpPr/>
          <p:nvPr/>
        </p:nvGrpSpPr>
        <p:grpSpPr>
          <a:xfrm>
            <a:off x="42862" y="3568888"/>
            <a:ext cx="6815138" cy="2685746"/>
            <a:chOff x="0" y="1246822"/>
            <a:chExt cx="6815138" cy="2685746"/>
          </a:xfrm>
        </p:grpSpPr>
        <p:sp>
          <p:nvSpPr>
            <p:cNvPr id="5" name="TextBox 4"/>
            <p:cNvSpPr txBox="1"/>
            <p:nvPr/>
          </p:nvSpPr>
          <p:spPr>
            <a:xfrm>
              <a:off x="0" y="1246822"/>
              <a:ext cx="120417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B</a:t>
              </a:r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irth weight</a:t>
              </a:r>
              <a:endParaRPr lang="en-GB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029" name="Picture 5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2863" y="1637043"/>
              <a:ext cx="6772275" cy="22955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grpSp>
        <p:nvGrpSpPr>
          <p:cNvPr id="11" name="Group 10"/>
          <p:cNvGrpSpPr/>
          <p:nvPr/>
        </p:nvGrpSpPr>
        <p:grpSpPr>
          <a:xfrm>
            <a:off x="42863" y="9413786"/>
            <a:ext cx="6837396" cy="2171700"/>
            <a:chOff x="20604" y="7399444"/>
            <a:chExt cx="6837396" cy="2171700"/>
          </a:xfrm>
        </p:grpSpPr>
        <p:sp>
          <p:nvSpPr>
            <p:cNvPr id="8" name="TextBox 7"/>
            <p:cNvSpPr txBox="1"/>
            <p:nvPr/>
          </p:nvSpPr>
          <p:spPr>
            <a:xfrm>
              <a:off x="20604" y="7399444"/>
              <a:ext cx="75212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D</a:t>
              </a:r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GA</a:t>
              </a:r>
              <a:endParaRPr lang="en-GB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031" name="Picture 7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5725" y="7799494"/>
              <a:ext cx="6772275" cy="17716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grpSp>
        <p:nvGrpSpPr>
          <p:cNvPr id="4" name="Group 3"/>
          <p:cNvGrpSpPr/>
          <p:nvPr/>
        </p:nvGrpSpPr>
        <p:grpSpPr>
          <a:xfrm>
            <a:off x="42862" y="1127978"/>
            <a:ext cx="6779244" cy="2440910"/>
            <a:chOff x="-29227" y="9729018"/>
            <a:chExt cx="6779244" cy="2440910"/>
          </a:xfrm>
        </p:grpSpPr>
        <p:sp>
          <p:nvSpPr>
            <p:cNvPr id="3" name="TextBox 2"/>
            <p:cNvSpPr txBox="1"/>
            <p:nvPr/>
          </p:nvSpPr>
          <p:spPr>
            <a:xfrm>
              <a:off x="-29227" y="9729018"/>
              <a:ext cx="19415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A</a:t>
              </a:r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Gestational  </a:t>
              </a:r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eight gain</a:t>
              </a:r>
              <a:endParaRPr lang="en-GB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0604" y="10085190"/>
              <a:ext cx="6729413" cy="2084738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82937425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85725" y="1193800"/>
            <a:ext cx="6928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E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FBS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5725" y="1706562"/>
            <a:ext cx="6772275" cy="212407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85725" y="4191205"/>
            <a:ext cx="7008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RBS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4712073"/>
            <a:ext cx="6768664" cy="1980454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7977" y="7071911"/>
            <a:ext cx="8803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G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HbA1c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977" y="7573963"/>
            <a:ext cx="6772275" cy="17811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8493849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525" y="2224087"/>
            <a:ext cx="6838950" cy="7743825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-88900" y="1511300"/>
            <a:ext cx="16962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tformin vs. glyburide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2169471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1219200"/>
            <a:ext cx="6415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) FBS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741487"/>
            <a:ext cx="6772275" cy="141922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-33663" y="3556000"/>
            <a:ext cx="6495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RBS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103" y="6668312"/>
            <a:ext cx="6772275" cy="12954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4405" y="6061095"/>
            <a:ext cx="8290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) HbA1c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4200137"/>
            <a:ext cx="6772275" cy="14287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966223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99</TotalTime>
  <Words>101</Words>
  <Application>Microsoft Office PowerPoint</Application>
  <PresentationFormat>Custom</PresentationFormat>
  <Paragraphs>22</Paragraphs>
  <Slides>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Clinical School Computing Servic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ne Adkins</dc:creator>
  <cp:lastModifiedBy>Jane</cp:lastModifiedBy>
  <cp:revision>58</cp:revision>
  <cp:lastPrinted>2019-07-02T08:32:21Z</cp:lastPrinted>
  <dcterms:created xsi:type="dcterms:W3CDTF">2019-06-24T08:28:53Z</dcterms:created>
  <dcterms:modified xsi:type="dcterms:W3CDTF">2020-02-20T19:47:24Z</dcterms:modified>
</cp:coreProperties>
</file>